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90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ra Perez Moro" userId="4500f17c-9844-4b59-9414-59df6e1f0f91" providerId="ADAL" clId="{2FE7D34E-916B-4E98-89D5-1202B333C99B}"/>
    <pc:docChg chg="modSld">
      <pc:chgData name="Clara Perez Moro" userId="4500f17c-9844-4b59-9414-59df6e1f0f91" providerId="ADAL" clId="{2FE7D34E-916B-4E98-89D5-1202B333C99B}" dt="2024-08-13T17:11:14.961" v="0" actId="20577"/>
      <pc:docMkLst>
        <pc:docMk/>
      </pc:docMkLst>
      <pc:sldChg chg="modSp">
        <pc:chgData name="Clara Perez Moro" userId="4500f17c-9844-4b59-9414-59df6e1f0f91" providerId="ADAL" clId="{2FE7D34E-916B-4E98-89D5-1202B333C99B}" dt="2024-08-13T17:11:14.961" v="0" actId="20577"/>
        <pc:sldMkLst>
          <pc:docMk/>
          <pc:sldMk cId="675425971" sldId="256"/>
        </pc:sldMkLst>
        <pc:graphicFrameChg chg="mod">
          <ac:chgData name="Clara Perez Moro" userId="4500f17c-9844-4b59-9414-59df6e1f0f91" providerId="ADAL" clId="{2FE7D34E-916B-4E98-89D5-1202B333C99B}" dt="2024-08-13T17:11:14.961" v="0" actId="20577"/>
          <ac:graphicFrameMkLst>
            <pc:docMk/>
            <pc:sldMk cId="675425971" sldId="256"/>
            <ac:graphicFrameMk id="4" creationId="{2E6F056B-071F-41E9-8865-AE5B672730DB}"/>
          </ac:graphicFrameMkLst>
        </pc:graphicFrameChg>
      </pc:sldChg>
    </pc:docChg>
  </pc:docChgLst>
  <pc:docChgLst>
    <pc:chgData name="Clara Perez Moro" userId="4500f17c-9844-4b59-9414-59df6e1f0f91" providerId="ADAL" clId="{80CD14B2-6759-4D14-9E26-4BD2DF1D4F6C}"/>
    <pc:docChg chg="modSld">
      <pc:chgData name="Clara Perez Moro" userId="4500f17c-9844-4b59-9414-59df6e1f0f91" providerId="ADAL" clId="{80CD14B2-6759-4D14-9E26-4BD2DF1D4F6C}" dt="2024-07-26T14:14:12.326" v="0" actId="255"/>
      <pc:docMkLst>
        <pc:docMk/>
      </pc:docMkLst>
      <pc:sldChg chg="modSp">
        <pc:chgData name="Clara Perez Moro" userId="4500f17c-9844-4b59-9414-59df6e1f0f91" providerId="ADAL" clId="{80CD14B2-6759-4D14-9E26-4BD2DF1D4F6C}" dt="2024-07-26T14:14:12.326" v="0" actId="255"/>
        <pc:sldMkLst>
          <pc:docMk/>
          <pc:sldMk cId="675425971" sldId="256"/>
        </pc:sldMkLst>
        <pc:spChg chg="mod">
          <ac:chgData name="Clara Perez Moro" userId="4500f17c-9844-4b59-9414-59df6e1f0f91" providerId="ADAL" clId="{80CD14B2-6759-4D14-9E26-4BD2DF1D4F6C}" dt="2024-07-26T14:14:12.326" v="0" actId="255"/>
          <ac:spMkLst>
            <pc:docMk/>
            <pc:sldMk cId="675425971" sldId="256"/>
            <ac:spMk id="5" creationId="{82CEF6B8-9FB0-4E84-89D4-B85541EA53A8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pvedues-my.sharepoint.com/personal/clapemo_upv_edu_es/Documents/articulo%20bsaseq/graficas%20usadas%20articulo/5a26%20usados%20para%20graficas,%20sintomas+qpcr-con%20gr&#225;fica%20s&#237;ntoma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907284946671191"/>
          <c:y val="5.9910688247302432E-2"/>
          <c:w val="0.69285063236109934"/>
          <c:h val="0.805507477954408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áfica síntomas'!$J$1</c:f>
              <c:strCache>
                <c:ptCount val="1"/>
                <c:pt idx="0">
                  <c:v>15 dpi</c:v>
                </c:pt>
              </c:strCache>
            </c:strRef>
          </c:tx>
          <c:spPr>
            <a:solidFill>
              <a:schemeClr val="accent6">
                <a:shade val="76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2.557888597258676E-2"/>
                </c:manualLayout>
              </c:layout>
              <c:tx>
                <c:rich>
                  <a:bodyPr/>
                  <a:lstStyle/>
                  <a:p>
                    <a:r>
                      <a:rPr lang="en-US" sz="900" b="0" i="0" u="none" strike="noStrike" kern="1200" baseline="0" dirty="0">
                        <a:solidFill>
                          <a:schemeClr val="tx1"/>
                        </a:solidFill>
                      </a:rPr>
                      <a:t>0.45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chemeClr val="tx1"/>
                        </a:solidFill>
                      </a:rPr>
                      <a:t>(0–2)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chemeClr val="tx1"/>
                        </a:solidFill>
                      </a:rPr>
                      <a:t>a</a:t>
                    </a:r>
                  </a:p>
                  <a:p>
                    <a:endParaRPr lang="en-US" dirty="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F856-44A8-9A84-CF62FD5CA9F4}"/>
                </c:ext>
              </c:extLst>
            </c:dLbl>
            <c:dLbl>
              <c:idx val="1"/>
              <c:layout>
                <c:manualLayout>
                  <c:x val="-2.4575983443547996E-5"/>
                  <c:y val="-1.0686060075823855E-2"/>
                </c:manualLayout>
              </c:layout>
              <c:tx>
                <c:rich>
                  <a:bodyPr/>
                  <a:lstStyle/>
                  <a:p>
                    <a:r>
                      <a:rPr lang="en-US" sz="900" b="0" i="0" u="none" strike="noStrike" kern="1200" baseline="0">
                        <a:solidFill>
                          <a:schemeClr val="tx1"/>
                        </a:solidFill>
                      </a:rPr>
                      <a:t>0</a:t>
                    </a:r>
                  </a:p>
                  <a:p>
                    <a:r>
                      <a:rPr lang="en-US" sz="900" b="0" i="0" u="none" strike="noStrike" kern="1200" baseline="0">
                        <a:solidFill>
                          <a:schemeClr val="tx1"/>
                        </a:solidFill>
                      </a:rPr>
                      <a:t>(0)</a:t>
                    </a:r>
                  </a:p>
                  <a:p>
                    <a:r>
                      <a:rPr lang="en-US" sz="900" b="0" i="0" u="none" strike="noStrike" kern="1200" baseline="0">
                        <a:solidFill>
                          <a:schemeClr val="tx1"/>
                        </a:solidFill>
                      </a:rPr>
                      <a:t>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856-44A8-9A84-CF62FD5CA9F4}"/>
                </c:ext>
              </c:extLst>
            </c:dLbl>
            <c:dLbl>
              <c:idx val="2"/>
              <c:layout>
                <c:manualLayout>
                  <c:x val="-1.0038670251908988E-16"/>
                  <c:y val="3.3150335374744738E-2"/>
                </c:manualLayout>
              </c:layout>
              <c:tx>
                <c:rich>
                  <a:bodyPr/>
                  <a:lstStyle/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0.6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(0–2)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a</a:t>
                    </a:r>
                  </a:p>
                  <a:p>
                    <a:endParaRPr lang="en-US" dirty="0">
                      <a:solidFill>
                        <a:sysClr val="windowText" lastClr="000000"/>
                      </a:solidFill>
                    </a:endParaRP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F856-44A8-9A84-CF62FD5CA9F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0"/>
              <a:lstStyle/>
              <a:p>
                <a:pPr algn="ctr" rtl="0">
                  <a:defRPr lang="es-ES"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gráfica síntomas'!$M$1:$M$3</c:f>
                <c:numCache>
                  <c:formatCode>General</c:formatCode>
                  <c:ptCount val="3"/>
                  <c:pt idx="0">
                    <c:v>0.1539355226213773</c:v>
                  </c:pt>
                  <c:pt idx="1">
                    <c:v>0</c:v>
                  </c:pt>
                  <c:pt idx="2">
                    <c:v>0.1147462648524424</c:v>
                  </c:pt>
                </c:numCache>
              </c:numRef>
            </c:plus>
            <c:minus>
              <c:numRef>
                <c:f>'gráfica síntomas'!$M$1:$M$3</c:f>
                <c:numCache>
                  <c:formatCode>General</c:formatCode>
                  <c:ptCount val="3"/>
                  <c:pt idx="0">
                    <c:v>0.1539355226213773</c:v>
                  </c:pt>
                  <c:pt idx="1">
                    <c:v>0</c:v>
                  </c:pt>
                  <c:pt idx="2">
                    <c:v>0.11474626485244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áfica síntomas'!$K$5:$K$7</c:f>
              <c:strCache>
                <c:ptCount val="3"/>
                <c:pt idx="0">
                  <c:v>A</c:v>
                </c:pt>
                <c:pt idx="1">
                  <c:v>B</c:v>
                </c:pt>
                <c:pt idx="2">
                  <c:v>H</c:v>
                </c:pt>
              </c:strCache>
            </c:strRef>
          </c:cat>
          <c:val>
            <c:numRef>
              <c:f>'gráfica síntomas'!$L$1:$L$3</c:f>
              <c:numCache>
                <c:formatCode>#,##0.00</c:formatCode>
                <c:ptCount val="3"/>
                <c:pt idx="0">
                  <c:v>0.45238095238095238</c:v>
                </c:pt>
                <c:pt idx="1">
                  <c:v>0</c:v>
                </c:pt>
                <c:pt idx="2">
                  <c:v>0.604651162790697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856-44A8-9A84-CF62FD5CA9F4}"/>
            </c:ext>
          </c:extLst>
        </c:ser>
        <c:ser>
          <c:idx val="1"/>
          <c:order val="1"/>
          <c:tx>
            <c:strRef>
              <c:f>'gráfica síntomas'!$J$5</c:f>
              <c:strCache>
                <c:ptCount val="1"/>
                <c:pt idx="0">
                  <c:v>30 dpi </c:v>
                </c:pt>
              </c:strCache>
            </c:strRef>
          </c:tx>
          <c:spPr>
            <a:solidFill>
              <a:schemeClr val="accent6">
                <a:tint val="77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5.0193351259544942E-17"/>
                  <c:y val="3.6809930008748909E-2"/>
                </c:manualLayout>
              </c:layout>
              <c:tx>
                <c:rich>
                  <a:bodyPr/>
                  <a:lstStyle/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0.95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(0–2)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a</a:t>
                    </a:r>
                  </a:p>
                  <a:p>
                    <a:endParaRPr lang="en-US" dirty="0">
                      <a:solidFill>
                        <a:sysClr val="windowText" lastClr="000000"/>
                      </a:solidFill>
                    </a:endParaRP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F856-44A8-9A84-CF62FD5CA9F4}"/>
                </c:ext>
              </c:extLst>
            </c:dLbl>
            <c:dLbl>
              <c:idx val="1"/>
              <c:layout>
                <c:manualLayout>
                  <c:x val="-1.0038670251908988E-16"/>
                  <c:y val="2.7537182852142633E-3"/>
                </c:manualLayout>
              </c:layout>
              <c:tx>
                <c:rich>
                  <a:bodyPr/>
                  <a:lstStyle/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0.05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(0–1)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F856-44A8-9A84-CF62FD5CA9F4}"/>
                </c:ext>
              </c:extLst>
            </c:dLbl>
            <c:dLbl>
              <c:idx val="2"/>
              <c:layout>
                <c:manualLayout>
                  <c:x val="-2.7378507871321013E-3"/>
                  <c:y val="4.3953776611256927E-2"/>
                </c:manualLayout>
              </c:layout>
              <c:tx>
                <c:rich>
                  <a:bodyPr/>
                  <a:lstStyle/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1.4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(0–4)</a:t>
                    </a:r>
                  </a:p>
                  <a:p>
                    <a:r>
                      <a:rPr lang="en-US" sz="900" b="0" i="0" u="none" strike="noStrike" kern="1200" baseline="0" dirty="0">
                        <a:solidFill>
                          <a:sysClr val="windowText" lastClr="000000"/>
                        </a:solidFill>
                      </a:rPr>
                      <a:t>c</a:t>
                    </a:r>
                  </a:p>
                  <a:p>
                    <a:endParaRPr lang="en-US" dirty="0">
                      <a:solidFill>
                        <a:sysClr val="windowText" lastClr="000000"/>
                      </a:solidFill>
                    </a:endParaRP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F856-44A8-9A84-CF62FD5CA9F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gráfica síntomas'!$M$5:$M$7</c:f>
                <c:numCache>
                  <c:formatCode>General</c:formatCode>
                  <c:ptCount val="3"/>
                  <c:pt idx="0">
                    <c:v>0.17561037061510262</c:v>
                  </c:pt>
                  <c:pt idx="1">
                    <c:v>4.9999999999999996E-2</c:v>
                  </c:pt>
                  <c:pt idx="2">
                    <c:v>0.11474626485244238</c:v>
                  </c:pt>
                </c:numCache>
              </c:numRef>
            </c:plus>
            <c:minus>
              <c:numRef>
                <c:f>'gráfica síntomas'!$M$5:$M$7</c:f>
                <c:numCache>
                  <c:formatCode>General</c:formatCode>
                  <c:ptCount val="3"/>
                  <c:pt idx="0">
                    <c:v>0.17561037061510262</c:v>
                  </c:pt>
                  <c:pt idx="1">
                    <c:v>4.9999999999999996E-2</c:v>
                  </c:pt>
                  <c:pt idx="2">
                    <c:v>0.114746264852442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áfica síntomas'!$K$5:$K$7</c:f>
              <c:strCache>
                <c:ptCount val="3"/>
                <c:pt idx="0">
                  <c:v>A</c:v>
                </c:pt>
                <c:pt idx="1">
                  <c:v>B</c:v>
                </c:pt>
                <c:pt idx="2">
                  <c:v>H</c:v>
                </c:pt>
              </c:strCache>
            </c:strRef>
          </c:cat>
          <c:val>
            <c:numRef>
              <c:f>'gráfica síntomas'!$L$5:$L$7</c:f>
              <c:numCache>
                <c:formatCode>#,##0</c:formatCode>
                <c:ptCount val="3"/>
                <c:pt idx="0">
                  <c:v>0.95238095238095233</c:v>
                </c:pt>
                <c:pt idx="1">
                  <c:v>0.05</c:v>
                </c:pt>
                <c:pt idx="2">
                  <c:v>1.39534883720930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856-44A8-9A84-CF62FD5CA9F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0"/>
        <c:axId val="402762800"/>
        <c:axId val="402763216"/>
      </c:barChart>
      <c:catAx>
        <c:axId val="40276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402763216"/>
        <c:crosses val="autoZero"/>
        <c:auto val="1"/>
        <c:lblAlgn val="ctr"/>
        <c:lblOffset val="100"/>
        <c:noMultiLvlLbl val="0"/>
      </c:catAx>
      <c:valAx>
        <c:axId val="402763216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dirty="0"/>
                  <a:t>ToLCNDV </a:t>
                </a:r>
                <a:r>
                  <a:rPr lang="es-ES" dirty="0" err="1"/>
                  <a:t>symptoms</a:t>
                </a:r>
                <a:r>
                  <a:rPr lang="es-ES" baseline="0" dirty="0"/>
                  <a:t> </a:t>
                </a:r>
                <a:r>
                  <a:rPr lang="es-ES" dirty="0"/>
                  <a:t> at 15  and 30 dpi</a:t>
                </a:r>
              </a:p>
            </c:rich>
          </c:tx>
          <c:layout>
            <c:manualLayout>
              <c:xMode val="edge"/>
              <c:yMode val="edge"/>
              <c:x val="0.11192484922957525"/>
              <c:y val="0.145717774861475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#,##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402762800"/>
        <c:crosses val="autoZero"/>
        <c:crossBetween val="between"/>
        <c:dispUnits>
          <c:custUnit val="1"/>
        </c:dispUnits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2764561000716801"/>
          <c:y val="6.6190580344123645E-2"/>
          <c:w val="0.26298510577579587"/>
          <c:h val="7.961839165008832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50">
          <a:solidFill>
            <a:sysClr val="windowText" lastClr="000000"/>
          </a:solidFill>
          <a:latin typeface="+mn-lt"/>
        </a:defRPr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9">
  <a:schemeClr val="accent6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7B1EB30-DCD6-400B-88D8-AFBBE54E56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ECC7801-F5F4-4DA3-AC88-1C945630BD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649348B-6A6C-4D34-9E74-200DF7959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7A59487-ED99-426E-BAD6-51AA754E3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C3237EA-0AF1-4C26-B46B-69F339C52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8271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69E6472-8664-41D4-AC6F-F9A69557F6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F9A4626-37E0-45F6-9AE2-C4C321620C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E39A0A4-26F8-4571-92F4-E65213D05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3834F29-7793-4B98-9865-B451828390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F94D4D4-8F41-419E-9498-9165AF4D6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8056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F720B6F-6CAA-4D37-9F77-7AC20C56BD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17EA65F-04E7-41C7-8347-84C19813EA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286FBF6-70ED-46F2-B315-C3BF01DA9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71379EB-05F7-4D2C-88A2-C6AE8FC5E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37973FF-AEF9-4AD1-AEEC-8FBC791B2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9484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D918A1D-7AE9-4FC7-9650-FBBF854E37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9E37BFE-526D-4B1F-9840-BA141D48D8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00359A8-F8D7-4494-A82A-4DF844D6F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D345294-248B-41EB-B24E-873C817EE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A12389A-C908-4509-8006-B25F2D072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2090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9CC554-2B75-4441-9E88-1EC9BEF65E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DD81057-32F5-4F01-94F5-8D2A5B7889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537D08B-21F5-4A43-9307-A986AABFF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465A532-9D94-4D32-BAD0-CB82610BA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9D37C99-E4C2-4672-A775-26E9FBF67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500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1C41394-CAE0-4FF3-8718-342800E2FC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406BF92-8A52-40EA-AEC3-D64EB8F7A9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B8128EF-33A6-4DEC-94B6-741380C74E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7D5B42E-EE7D-4047-9B6D-DD2903320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8472AFC-9C82-4760-803F-28F78D690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41F7FA0-1C2D-40F1-BD33-D9021A134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7268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721590B-C20B-423C-97D4-1393CFEDF9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F537CEF-1485-4C3C-AAB8-08954FAC8A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B6C6CD1-1DD3-48E8-93CF-3D92CC5AC5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F4428C7-E19E-40DC-AFF4-D88960340A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EB0FAFE-3FC5-4AC4-908E-AFAD176B1C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41F41590-0E6A-4D30-86A2-8FC13A23F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945F5E7C-A874-49D3-83E9-9EF0DB69F8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9546A02-4E1A-4145-BBBD-7E650E7E9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8363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94899EA-995B-4DD2-B789-0CC44B86B1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AC0250EB-F2D8-4782-905E-8FAEF340E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6CF4722-35B2-44BD-9DF8-6401497D8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BFA835A-56F1-4EBC-81B4-6BA12A2EB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2135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6153B87-3B8C-4CAF-AA33-1EB53565C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B0FD70F-7DAF-48A9-96E8-01658E934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B71092A-723D-4E4A-ACF2-426C88107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9924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4457D4B-2C0B-40D0-B61D-0DCB47C186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23954B5-9852-418C-8DAF-9FECAC4358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EEA1B2E-7E12-4FE5-949B-FBB9D7BFDD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5FF5425-7C2F-4E21-B854-41EE47014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4A2CFEF-E974-4F71-B255-35C58D933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FFF6C3F-9ABC-4904-AD41-78C7F4BE0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98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C8C189-C885-4628-960B-ADDBFA765B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E8F2715-8DCE-4356-95D8-EDA1E50A6E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85AEC0D-90B0-4811-816D-FE714525F1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6B5BF64-1A8E-46B4-A7E6-CF16A1B8B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2C540F7-2701-43A2-AC6D-FA64EB5ED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79396C0-2E49-45B7-A8D5-BBDDF77418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431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FDDD5B9-BC98-4540-A53E-8E67650D12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9E9A68C-D903-48BC-9C96-3614A0A6C8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D51945C-B9B1-4A62-93CA-6FDC0FE959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A47ED0-443E-4632-A1EA-AF5368464D03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C7F921E-1A2E-4575-96A4-54C621BC1D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C140E2C-ACDB-4149-B5DE-756780D1E4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AB7A6-DBBA-402B-9E72-4A87866219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094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2E6F056B-071F-41E9-8865-AE5B672730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6610413"/>
              </p:ext>
            </p:extLst>
          </p:nvPr>
        </p:nvGraphicFramePr>
        <p:xfrm>
          <a:off x="3776662" y="2057400"/>
          <a:ext cx="5078089" cy="29158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ángulo 4">
            <a:extLst>
              <a:ext uri="{FF2B5EF4-FFF2-40B4-BE49-F238E27FC236}">
                <a16:creationId xmlns:a16="http://schemas.microsoft.com/office/drawing/2014/main" id="{82CEF6B8-9FB0-4E84-89D4-B85541EA53A8}"/>
              </a:ext>
            </a:extLst>
          </p:cNvPr>
          <p:cNvSpPr/>
          <p:nvPr/>
        </p:nvSpPr>
        <p:spPr>
          <a:xfrm>
            <a:off x="-1337389" y="120646"/>
            <a:ext cx="13364547" cy="5528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050" b="1" kern="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050" kern="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oLCNDV symptoms at 15 dpi (days post inoculation) and 30 dpi in F</a:t>
            </a:r>
            <a:r>
              <a:rPr lang="en-US" sz="1050" kern="100" baseline="-25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050" kern="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lants derived from the initial cross WM-7 × RC. Genotypes are classified according to the genotype for the three </a:t>
            </a:r>
            <a:r>
              <a:rPr lang="en-US" sz="1050" kern="1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segregating</a:t>
            </a:r>
            <a:r>
              <a:rPr lang="en-US" sz="1050" kern="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arkers SNPCmND13bis, NDHRM26, and NDHRM08, where A is homozygous for RC allele, H is heterozygous, and B is homozygous for WM-7 allele. Bars represent standard error. Different letters indicate significant differences among genotypes at the same date (p &lt; 0.05, LSD test). Average and range of symptoms are shown above the bars.</a:t>
            </a:r>
            <a:endParaRPr lang="es-ES" sz="1050" kern="1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54259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ac11dba3-a5bf-4109-b6d8-2d7189acde41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42C51A07E366E41BA3F6D684A5F4E02" ma:contentTypeVersion="16" ma:contentTypeDescription="Crear nuevo documento." ma:contentTypeScope="" ma:versionID="e1b0650f5306ad42ca79d3f7092c9ba5">
  <xsd:schema xmlns:xsd="http://www.w3.org/2001/XMLSchema" xmlns:xs="http://www.w3.org/2001/XMLSchema" xmlns:p="http://schemas.microsoft.com/office/2006/metadata/properties" xmlns:ns3="ac11dba3-a5bf-4109-b6d8-2d7189acde41" xmlns:ns4="42d3858e-7e72-47df-8373-1d7970fb6d45" targetNamespace="http://schemas.microsoft.com/office/2006/metadata/properties" ma:root="true" ma:fieldsID="d47e351fbff462c8b50b3875fd3b8777" ns3:_="" ns4:_="">
    <xsd:import namespace="ac11dba3-a5bf-4109-b6d8-2d7189acde41"/>
    <xsd:import namespace="42d3858e-7e72-47df-8373-1d7970fb6d4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LengthInSeconds" minOccurs="0"/>
                <xsd:element ref="ns3:MediaServiceSearchPropertie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c11dba3-a5bf-4109-b6d8-2d7189acde4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_activity" ma:index="17" nillable="true" ma:displayName="_activity" ma:hidden="true" ma:internalName="_activity">
      <xsd:simpleType>
        <xsd:restriction base="dms:Note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2d3858e-7e72-47df-8373-1d7970fb6d45" elementFormDefault="qualified">
    <xsd:import namespace="http://schemas.microsoft.com/office/2006/documentManagement/types"/>
    <xsd:import namespace="http://schemas.microsoft.com/office/infopath/2007/PartnerControls"/>
    <xsd:element name="SharedWithUsers" ma:index="20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2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A174DBD-A6B1-4B33-963F-3E051DA0AAE6}">
  <ds:schemaRefs>
    <ds:schemaRef ds:uri="http://schemas.openxmlformats.org/package/2006/metadata/core-properties"/>
    <ds:schemaRef ds:uri="http://schemas.microsoft.com/office/2006/documentManagement/types"/>
    <ds:schemaRef ds:uri="http://purl.org/dc/terms/"/>
    <ds:schemaRef ds:uri="http://schemas.microsoft.com/office/2006/metadata/properties"/>
    <ds:schemaRef ds:uri="42d3858e-7e72-47df-8373-1d7970fb6d45"/>
    <ds:schemaRef ds:uri="http://schemas.microsoft.com/office/infopath/2007/PartnerControls"/>
    <ds:schemaRef ds:uri="http://www.w3.org/XML/1998/namespace"/>
    <ds:schemaRef ds:uri="http://purl.org/dc/elements/1.1/"/>
    <ds:schemaRef ds:uri="ac11dba3-a5bf-4109-b6d8-2d7189acde41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62C88428-7043-48A0-8C7C-A949A992144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C624659-5B28-4CF9-ABFC-520DFF7BCED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c11dba3-a5bf-4109-b6d8-2d7189acde41"/>
    <ds:schemaRef ds:uri="42d3858e-7e72-47df-8373-1d7970fb6d4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39</Words>
  <Application>Microsoft Office PowerPoint</Application>
  <PresentationFormat>Panorámica</PresentationFormat>
  <Paragraphs>2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Perez Moro</dc:creator>
  <cp:lastModifiedBy>Clara Perez Moro</cp:lastModifiedBy>
  <cp:revision>1</cp:revision>
  <dcterms:created xsi:type="dcterms:W3CDTF">2024-07-19T14:38:00Z</dcterms:created>
  <dcterms:modified xsi:type="dcterms:W3CDTF">2024-08-13T17:14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42C51A07E366E41BA3F6D684A5F4E02</vt:lpwstr>
  </property>
</Properties>
</file>